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jpeg" ContentType="image/jpeg"/>
  <Override PartName="/ppt/media/image8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7091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4E3F5-2859-4D59-8565-8635F42EB3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72C4C-FB38-4E2E-BC63-5A20D6D2BD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3D9E4-9176-4149-90DD-8309DB7470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1CC84-0797-4CE8-BB43-20DEEA59AB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EB732-E77D-4A6F-85E4-A138FFA4EB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9E41D-B55B-4C65-A3AF-B7FECBED42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E5C11-EC2D-4801-9F59-4A6B4A1762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93B00-B12E-4B24-BF59-FCAD65FC90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F1D65-2027-45E9-A81F-68F684D831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53459-CAD8-41FD-927A-AA668D0E61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E7F30-E3BE-48C6-BA8B-7545486A49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D1BBE-023C-488A-8407-02EB38A3B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D35DB0-AC04-4F2E-8C7D-347033F2C08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1"/>
          <p:cNvSpPr/>
          <p:nvPr/>
        </p:nvSpPr>
        <p:spPr>
          <a:xfrm>
            <a:off x="442440" y="366840"/>
            <a:ext cx="168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72" descr="duct sglt1 parotid dm tudo.tif"/>
          <p:cNvPicPr/>
          <p:nvPr/>
        </p:nvPicPr>
        <p:blipFill>
          <a:blip r:embed="rId1"/>
          <a:stretch/>
        </p:blipFill>
        <p:spPr>
          <a:xfrm>
            <a:off x="2116080" y="1254240"/>
            <a:ext cx="1484280" cy="14414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31" descr="duct sglt1 parotid SHR tudo 2.tif"/>
          <p:cNvPicPr/>
          <p:nvPr/>
        </p:nvPicPr>
        <p:blipFill>
          <a:blip r:embed="rId2"/>
          <a:stretch/>
        </p:blipFill>
        <p:spPr>
          <a:xfrm>
            <a:off x="3559320" y="1265400"/>
            <a:ext cx="1218960" cy="14396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76" descr="duct sglt1 parotid shrdm tudo 2.tif"/>
          <p:cNvPicPr/>
          <p:nvPr/>
        </p:nvPicPr>
        <p:blipFill>
          <a:blip r:embed="rId3"/>
          <a:stretch/>
        </p:blipFill>
        <p:spPr>
          <a:xfrm>
            <a:off x="4781520" y="1260360"/>
            <a:ext cx="1467000" cy="14922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71" descr="duct sglt1 parotid dm green.tif"/>
          <p:cNvPicPr/>
          <p:nvPr/>
        </p:nvPicPr>
        <p:blipFill>
          <a:blip r:embed="rId4"/>
          <a:stretch/>
        </p:blipFill>
        <p:spPr>
          <a:xfrm>
            <a:off x="2130480" y="2757600"/>
            <a:ext cx="1458720" cy="14619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0" descr="duct sglt1 parotid SHR green 2 - Copy.tif"/>
          <p:cNvPicPr/>
          <p:nvPr/>
        </p:nvPicPr>
        <p:blipFill>
          <a:blip r:embed="rId5"/>
          <a:stretch/>
        </p:blipFill>
        <p:spPr>
          <a:xfrm>
            <a:off x="3581280" y="2760840"/>
            <a:ext cx="1209960" cy="14396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69" descr="duct sglt1 parotid control tudo.tif"/>
          <p:cNvPicPr/>
          <p:nvPr/>
        </p:nvPicPr>
        <p:blipFill>
          <a:blip r:embed="rId6"/>
          <a:stretch/>
        </p:blipFill>
        <p:spPr>
          <a:xfrm>
            <a:off x="627120" y="1239840"/>
            <a:ext cx="1477800" cy="14652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70" descr="duct sglt1 parotid control green.tif"/>
          <p:cNvPicPr/>
          <p:nvPr/>
        </p:nvPicPr>
        <p:blipFill>
          <a:blip r:embed="rId7"/>
          <a:stretch/>
        </p:blipFill>
        <p:spPr>
          <a:xfrm>
            <a:off x="635040" y="2749680"/>
            <a:ext cx="1498680" cy="14796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7" descr="ducto green.tif"/>
          <p:cNvPicPr/>
          <p:nvPr/>
        </p:nvPicPr>
        <p:blipFill>
          <a:blip r:embed="rId8"/>
          <a:stretch/>
        </p:blipFill>
        <p:spPr>
          <a:xfrm>
            <a:off x="4809960" y="2762280"/>
            <a:ext cx="1447920" cy="1438200"/>
          </a:xfrm>
          <a:prstGeom prst="rect">
            <a:avLst/>
          </a:prstGeom>
          <a:ln w="0">
            <a:noFill/>
          </a:ln>
        </p:spPr>
      </p:pic>
      <p:sp>
        <p:nvSpPr>
          <p:cNvPr id="50" name="Line 2538"/>
          <p:cNvSpPr/>
          <p:nvPr/>
        </p:nvSpPr>
        <p:spPr>
          <a:xfrm>
            <a:off x="2097000" y="1238400"/>
            <a:ext cx="23760" cy="2990880"/>
          </a:xfrm>
          <a:prstGeom prst="line">
            <a:avLst/>
          </a:prstGeom>
          <a:ln w="34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541"/>
          <p:cNvSpPr/>
          <p:nvPr/>
        </p:nvSpPr>
        <p:spPr>
          <a:xfrm>
            <a:off x="612720" y="1236600"/>
            <a:ext cx="5657760" cy="299268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543"/>
          <p:cNvSpPr/>
          <p:nvPr/>
        </p:nvSpPr>
        <p:spPr>
          <a:xfrm>
            <a:off x="612720" y="2711520"/>
            <a:ext cx="5643720" cy="3168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223"/>
          <p:cNvSpPr/>
          <p:nvPr/>
        </p:nvSpPr>
        <p:spPr>
          <a:xfrm>
            <a:off x="693720" y="4113360"/>
            <a:ext cx="21600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220"/>
          <p:cNvSpPr/>
          <p:nvPr/>
        </p:nvSpPr>
        <p:spPr>
          <a:xfrm>
            <a:off x="806760" y="950760"/>
            <a:ext cx="521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3908520"/>
                <a:tab algn="l" pos="781668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1" lang="pt-BR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WKY                                  WKY-D                            SHR                               SHR-D</a:t>
            </a: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170"/>
          <p:cNvSpPr/>
          <p:nvPr/>
        </p:nvSpPr>
        <p:spPr>
          <a:xfrm>
            <a:off x="3029400" y="64296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3908520"/>
                <a:tab algn="l" pos="781668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Paroti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54"/>
          <p:cNvSpPr/>
          <p:nvPr/>
        </p:nvSpPr>
        <p:spPr>
          <a:xfrm>
            <a:off x="567000" y="1251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6"/>
          <p:cNvSpPr/>
          <p:nvPr/>
        </p:nvSpPr>
        <p:spPr>
          <a:xfrm>
            <a:off x="2070360" y="12445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7"/>
          <p:cNvSpPr/>
          <p:nvPr/>
        </p:nvSpPr>
        <p:spPr>
          <a:xfrm>
            <a:off x="3586320" y="12654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58"/>
          <p:cNvSpPr/>
          <p:nvPr/>
        </p:nvSpPr>
        <p:spPr>
          <a:xfrm>
            <a:off x="4839840" y="12812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59"/>
          <p:cNvSpPr/>
          <p:nvPr/>
        </p:nvSpPr>
        <p:spPr>
          <a:xfrm>
            <a:off x="581400" y="27194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60"/>
          <p:cNvSpPr/>
          <p:nvPr/>
        </p:nvSpPr>
        <p:spPr>
          <a:xfrm>
            <a:off x="2076480" y="27194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61"/>
          <p:cNvSpPr/>
          <p:nvPr/>
        </p:nvSpPr>
        <p:spPr>
          <a:xfrm>
            <a:off x="3557520" y="271944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62"/>
          <p:cNvSpPr/>
          <p:nvPr/>
        </p:nvSpPr>
        <p:spPr>
          <a:xfrm>
            <a:off x="4838760" y="2747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f7f735"/>
                </a:solidFill>
                <a:latin typeface="Arial"/>
                <a:ea typeface="Times New Roman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hevron 73"/>
          <p:cNvSpPr/>
          <p:nvPr/>
        </p:nvSpPr>
        <p:spPr>
          <a:xfrm>
            <a:off x="1028880" y="3363840"/>
            <a:ext cx="95040" cy="85680"/>
          </a:xfrm>
          <a:custGeom>
            <a:avLst/>
            <a:gdLst>
              <a:gd name="textAreaLeft" fmla="*/ 0 w 95040"/>
              <a:gd name="textAreaRight" fmla="*/ 95400 w 9504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1880" y="0"/>
                </a:lnTo>
                <a:lnTo>
                  <a:pt x="21600" y="10800"/>
                </a:lnTo>
                <a:lnTo>
                  <a:pt x="11880" y="21600"/>
                </a:lnTo>
                <a:lnTo>
                  <a:pt x="0" y="21600"/>
                </a:lnTo>
                <a:lnTo>
                  <a:pt x="9720" y="10800"/>
                </a:lnTo>
                <a:close/>
              </a:path>
            </a:pathLst>
          </a:cu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hevron 74"/>
          <p:cNvSpPr/>
          <p:nvPr/>
        </p:nvSpPr>
        <p:spPr>
          <a:xfrm>
            <a:off x="1000080" y="1849320"/>
            <a:ext cx="95400" cy="85680"/>
          </a:xfrm>
          <a:custGeom>
            <a:avLst/>
            <a:gdLst>
              <a:gd name="textAreaLeft" fmla="*/ 0 w 95400"/>
              <a:gd name="textAreaRight" fmla="*/ 95760 w 9540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1880" y="0"/>
                </a:lnTo>
                <a:lnTo>
                  <a:pt x="21600" y="10800"/>
                </a:lnTo>
                <a:lnTo>
                  <a:pt x="11880" y="21600"/>
                </a:lnTo>
                <a:lnTo>
                  <a:pt x="0" y="21600"/>
                </a:lnTo>
                <a:lnTo>
                  <a:pt x="9720" y="10800"/>
                </a:lnTo>
                <a:close/>
              </a:path>
            </a:pathLst>
          </a:cu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ight Arrow 83"/>
          <p:cNvSpPr/>
          <p:nvPr/>
        </p:nvSpPr>
        <p:spPr>
          <a:xfrm rot="2704200">
            <a:off x="2733120" y="1827000"/>
            <a:ext cx="152640" cy="5724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ight Arrow 84"/>
          <p:cNvSpPr/>
          <p:nvPr/>
        </p:nvSpPr>
        <p:spPr>
          <a:xfrm rot="2704200">
            <a:off x="2772720" y="3354120"/>
            <a:ext cx="152640" cy="5724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ight Arrow 83"/>
          <p:cNvSpPr/>
          <p:nvPr/>
        </p:nvSpPr>
        <p:spPr>
          <a:xfrm rot="2704200">
            <a:off x="3971520" y="1731960"/>
            <a:ext cx="152280" cy="57240"/>
          </a:xfrm>
          <a:prstGeom prst="rightArrow">
            <a:avLst>
              <a:gd name="adj1" fmla="val 50000"/>
              <a:gd name="adj2" fmla="val 49882"/>
            </a:avLst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ight Arrow 84"/>
          <p:cNvSpPr/>
          <p:nvPr/>
        </p:nvSpPr>
        <p:spPr>
          <a:xfrm rot="2704200">
            <a:off x="4020480" y="3287520"/>
            <a:ext cx="152640" cy="5724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ight Arrow 83"/>
          <p:cNvSpPr/>
          <p:nvPr/>
        </p:nvSpPr>
        <p:spPr>
          <a:xfrm rot="19818600">
            <a:off x="5457960" y="2274480"/>
            <a:ext cx="152280" cy="57240"/>
          </a:xfrm>
          <a:prstGeom prst="rightArrow">
            <a:avLst>
              <a:gd name="adj1" fmla="val 50000"/>
              <a:gd name="adj2" fmla="val 49882"/>
            </a:avLst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ight Arrow 84"/>
          <p:cNvSpPr/>
          <p:nvPr/>
        </p:nvSpPr>
        <p:spPr>
          <a:xfrm rot="19818600">
            <a:off x="5440320" y="3744720"/>
            <a:ext cx="152280" cy="56880"/>
          </a:xfrm>
          <a:prstGeom prst="rightArrow">
            <a:avLst>
              <a:gd name="adj1" fmla="val 50000"/>
              <a:gd name="adj2" fmla="val 50198"/>
            </a:avLst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2540"/>
          <p:cNvSpPr/>
          <p:nvPr/>
        </p:nvSpPr>
        <p:spPr>
          <a:xfrm flipH="1">
            <a:off x="4795920" y="1260360"/>
            <a:ext cx="7920" cy="296892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2539"/>
          <p:cNvSpPr/>
          <p:nvPr/>
        </p:nvSpPr>
        <p:spPr>
          <a:xfrm>
            <a:off x="3556080" y="1238400"/>
            <a:ext cx="4680" cy="2990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aixaDeTexto 34"/>
          <p:cNvSpPr/>
          <p:nvPr/>
        </p:nvSpPr>
        <p:spPr>
          <a:xfrm>
            <a:off x="609480" y="4411800"/>
            <a:ext cx="566100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Immunolocalization of SGLT1 protein in ductal cells of parotid glands of Wistar Kyoto rats (WKY), diabetic WKY (WKY-D), spontaneously hypertensive rats (SHR) and diabetic SHR (SHR-D)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SGLT1 (green), F-actin (red) and nuclear marker (blue)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only SGLT1 in green color. SGLT1 protein in ductal cells of WKY can be seen in a very low intensity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whereas the SGLT1 immunoreactivity is clearly observed in WKY-D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SHR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; a further increase in SGLT1 can be observed in SHR-D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Arrowheads and arrows indicate absence or presence of SGLT1 protein in luminal membrane of ductal cells; respectively. Scale bar, 20 µm. Images are representative of 4 animals in each grou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4T10:23:35Z</dcterms:created>
  <dc:creator>ubiratan</dc:creator>
  <dc:description/>
  <dc:language>en-US</dc:language>
  <cp:lastModifiedBy>Robinson</cp:lastModifiedBy>
  <dcterms:modified xsi:type="dcterms:W3CDTF">2012-03-05T17:08:22Z</dcterms:modified>
  <cp:revision>140</cp:revision>
  <dc:subject/>
  <dc:title>Slide 1</dc:title>
</cp:coreProperties>
</file>